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1"/>
  </p:normalViewPr>
  <p:slideViewPr>
    <p:cSldViewPr snapToGrid="0">
      <p:cViewPr varScale="1">
        <p:scale>
          <a:sx n="107" d="100"/>
          <a:sy n="107" d="100"/>
        </p:scale>
        <p:origin x="7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90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85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465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610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023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675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913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081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789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251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307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2FB7AA-55C3-4C3A-90D5-8654D66B6637}" type="datetimeFigureOut">
              <a:rPr lang="en-US" smtClean="0"/>
              <a:t>1/1/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BF3455-ED47-4F72-A00F-6C15FAB7EB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728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ángulo 6"/>
          <p:cNvSpPr/>
          <p:nvPr/>
        </p:nvSpPr>
        <p:spPr>
          <a:xfrm>
            <a:off x="2087880" y="5852159"/>
            <a:ext cx="809853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0" i="0" dirty="0">
                <a:solidFill>
                  <a:srgbClr val="333333"/>
                </a:solidFill>
                <a:effectLst/>
                <a:latin typeface="Ubuntu"/>
              </a:rPr>
              <a:t>Note: DDN: Deep Dry Needling; MT: Manual Therapy; CT: Cognitive therapy; BTX: Botulinum Toxin; PL: Placebo.</a:t>
            </a:r>
            <a:endParaRPr lang="en-US" sz="1400" dirty="0"/>
          </a:p>
        </p:txBody>
      </p:sp>
      <p:pic>
        <p:nvPicPr>
          <p:cNvPr id="1026" name="Picture 2" descr="Note: DDN: Deep Dry Needling; MT: Manual Therapy; CT: Cognitive therapy; BTX: Botulinum Toxin; PL: Placebo.">
            <a:extLst>
              <a:ext uri="{FF2B5EF4-FFF2-40B4-BE49-F238E27FC236}">
                <a16:creationId xmlns:a16="http://schemas.microsoft.com/office/drawing/2014/main" id="{1B3C45BF-58E5-6C40-9ECE-4B700531F8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2645" y="482621"/>
            <a:ext cx="7266709" cy="51905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929585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Macintosh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Ubuntu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itor Martin-Pintado Zugasti</dc:creator>
  <cp:lastModifiedBy>Microsoft Office User</cp:lastModifiedBy>
  <cp:revision>3</cp:revision>
  <dcterms:created xsi:type="dcterms:W3CDTF">2021-12-07T14:57:11Z</dcterms:created>
  <dcterms:modified xsi:type="dcterms:W3CDTF">2022-01-01T20:39:09Z</dcterms:modified>
</cp:coreProperties>
</file>